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36" y="5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031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544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204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23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34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4800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237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856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368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90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1912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9DD5B-CEC0-4F21-8415-34D6EBB7F74D}" type="datetimeFigureOut">
              <a:rPr lang="zh-CN" altLang="en-US" smtClean="0"/>
              <a:t>2022/8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B051F-6D3E-4A16-85B9-BA8A475140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3702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332656" y="7297227"/>
            <a:ext cx="63093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upplementary Fig. 1 </a:t>
            </a:r>
            <a:r>
              <a:rPr lang="en-US" altLang="zh-CN" sz="12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M</a:t>
            </a:r>
            <a:r>
              <a:rPr lang="en-US" altLang="zh-CN" sz="12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ultiple sequences alignment and phylogeny evolutionary </a:t>
            </a:r>
            <a:r>
              <a:rPr lang="en-US" altLang="zh-CN" sz="12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nalyses </a:t>
            </a:r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f the </a:t>
            </a:r>
            <a:r>
              <a:rPr lang="en-US" altLang="zh-CN" sz="12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5-CMS mitochondria-encoded ORF188, ORF222a and ORF261a proteins.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-C. Full-length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rotein sequence alignment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f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5-CMS</a:t>
            </a:r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RF188a,ORF222a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nd ORF261a proteins with homologs. The amino acid sequence of C5-CMS_ORF188 and C5-CMS_ORF261 are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identical to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that previously published for B. </a:t>
            </a:r>
            <a:r>
              <a:rPr lang="en-US" altLang="zh-CN" sz="1200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apus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owever,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5-CMS_ORF222 is a chimeric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rotein.</a:t>
            </a:r>
            <a:r>
              <a:rPr lang="zh-CN" altLang="en-US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. Phylogenetic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tree showing that putative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RF188, ORF222a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nd ORF261a homologs are present in </a:t>
            </a:r>
            <a:r>
              <a:rPr lang="en-US" altLang="zh-CN" sz="12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rassica </a:t>
            </a:r>
            <a:r>
              <a:rPr lang="en-US" altLang="zh-CN" sz="12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apus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</a:t>
            </a:r>
            <a:r>
              <a:rPr lang="en-US" altLang="zh-CN" sz="12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rabidopsis thaliana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nd</a:t>
            </a:r>
            <a:r>
              <a:rPr lang="en-US" altLang="zh-CN" sz="1200" i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Brassica </a:t>
            </a:r>
            <a:r>
              <a:rPr lang="en-US" altLang="zh-CN" sz="1200" i="1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leracea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. 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The peptide sequences of the putative ORF188 proteins were used to construct a neighbor-joining phylogenetic tree with </a:t>
            </a:r>
            <a:r>
              <a:rPr lang="en-US" altLang="zh-CN" sz="12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2000 bootstrap replicates.</a:t>
            </a:r>
            <a:endParaRPr lang="en-US" altLang="zh-CN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21" name="组合 20"/>
          <p:cNvGrpSpPr/>
          <p:nvPr/>
        </p:nvGrpSpPr>
        <p:grpSpPr>
          <a:xfrm>
            <a:off x="188640" y="2112650"/>
            <a:ext cx="6480720" cy="1348318"/>
            <a:chOff x="260648" y="2906579"/>
            <a:chExt cx="6480720" cy="1460677"/>
          </a:xfrm>
        </p:grpSpPr>
        <p:pic>
          <p:nvPicPr>
            <p:cNvPr id="1027" name="Picture 3" descr="C:\Users\xiong\Desktop\orf222a.em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45" r="764" b="11851"/>
            <a:stretch/>
          </p:blipFill>
          <p:spPr bwMode="auto">
            <a:xfrm>
              <a:off x="1371022" y="3008784"/>
              <a:ext cx="5370346" cy="129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" name="组合 22"/>
            <p:cNvGrpSpPr/>
            <p:nvPr/>
          </p:nvGrpSpPr>
          <p:grpSpPr>
            <a:xfrm>
              <a:off x="260648" y="2906579"/>
              <a:ext cx="1512168" cy="524574"/>
              <a:chOff x="260648" y="920552"/>
              <a:chExt cx="1512168" cy="524574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260648" y="1178387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48680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o_atp8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260648" y="3368824"/>
              <a:ext cx="1656184" cy="524574"/>
              <a:chOff x="260648" y="920552"/>
              <a:chExt cx="1656184" cy="524574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260648" y="1178387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692696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o_atp8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31" name="组合 30"/>
            <p:cNvGrpSpPr/>
            <p:nvPr/>
          </p:nvGrpSpPr>
          <p:grpSpPr>
            <a:xfrm>
              <a:off x="260648" y="3872880"/>
              <a:ext cx="1512168" cy="494376"/>
              <a:chOff x="260648" y="920552"/>
              <a:chExt cx="1512168" cy="494376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60648" y="1148189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76672" y="920552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222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48680" y="1034371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o_atp8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</p:grpSp>
      <p:grpSp>
        <p:nvGrpSpPr>
          <p:cNvPr id="35" name="组合 34"/>
          <p:cNvGrpSpPr/>
          <p:nvPr/>
        </p:nvGrpSpPr>
        <p:grpSpPr>
          <a:xfrm>
            <a:off x="188640" y="3641438"/>
            <a:ext cx="6480720" cy="1376192"/>
            <a:chOff x="260648" y="4490755"/>
            <a:chExt cx="6480720" cy="1490875"/>
          </a:xfrm>
        </p:grpSpPr>
        <p:sp>
          <p:nvSpPr>
            <p:cNvPr id="39" name="TextBox 38"/>
            <p:cNvSpPr txBox="1"/>
            <p:nvPr/>
          </p:nvSpPr>
          <p:spPr>
            <a:xfrm>
              <a:off x="476672" y="4490755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na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pic>
          <p:nvPicPr>
            <p:cNvPr id="1031" name="Picture 7" descr="C:\Users\xiong\Desktop\orf261a-1.emf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81" r="837" b="6904"/>
            <a:stretch/>
          </p:blipFill>
          <p:spPr bwMode="auto">
            <a:xfrm>
              <a:off x="1377368" y="4582936"/>
              <a:ext cx="5364000" cy="13781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" name="TextBox 41"/>
            <p:cNvSpPr txBox="1"/>
            <p:nvPr/>
          </p:nvSpPr>
          <p:spPr>
            <a:xfrm>
              <a:off x="260648" y="4613865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5-CMS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48680" y="4736977"/>
              <a:ext cx="1008112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o_orf266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76672" y="4964614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na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60648" y="5087724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5-CMS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48680" y="5210835"/>
              <a:ext cx="1008112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o_orf266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6672" y="5468670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na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60648" y="5591780"/>
              <a:ext cx="1224136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5-CMS_orf261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48680" y="5714890"/>
              <a:ext cx="1008112" cy="266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o_orf266a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116632" y="185053"/>
            <a:ext cx="6552728" cy="1861129"/>
            <a:chOff x="188640" y="560512"/>
            <a:chExt cx="6552728" cy="2016224"/>
          </a:xfrm>
        </p:grpSpPr>
        <p:pic>
          <p:nvPicPr>
            <p:cNvPr id="1026" name="Picture 2" descr="C:\Users\xiong\Desktop\188.em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85"/>
            <a:stretch/>
          </p:blipFill>
          <p:spPr bwMode="auto">
            <a:xfrm>
              <a:off x="1343672" y="635685"/>
              <a:ext cx="5397696" cy="19410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" name="组合 4"/>
            <p:cNvGrpSpPr/>
            <p:nvPr/>
          </p:nvGrpSpPr>
          <p:grpSpPr>
            <a:xfrm>
              <a:off x="188640" y="560512"/>
              <a:ext cx="1584176" cy="482763"/>
              <a:chOff x="188640" y="920552"/>
              <a:chExt cx="1584176" cy="482763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8640" y="1136576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48680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Ath_atp6-2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52" name="组合 51"/>
            <p:cNvGrpSpPr/>
            <p:nvPr/>
          </p:nvGrpSpPr>
          <p:grpSpPr>
            <a:xfrm>
              <a:off x="188640" y="1034371"/>
              <a:ext cx="1584176" cy="482763"/>
              <a:chOff x="188640" y="920552"/>
              <a:chExt cx="1584176" cy="482763"/>
            </a:xfrm>
          </p:grpSpPr>
          <p:sp>
            <p:nvSpPr>
              <p:cNvPr id="53" name="TextBox 52"/>
              <p:cNvSpPr txBox="1"/>
              <p:nvPr/>
            </p:nvSpPr>
            <p:spPr>
              <a:xfrm>
                <a:off x="188640" y="1136576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548680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Ath_atp6-2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56" name="组合 55"/>
            <p:cNvGrpSpPr/>
            <p:nvPr/>
          </p:nvGrpSpPr>
          <p:grpSpPr>
            <a:xfrm>
              <a:off x="188640" y="1538427"/>
              <a:ext cx="1584176" cy="482763"/>
              <a:chOff x="188640" y="920552"/>
              <a:chExt cx="1584176" cy="482763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188640" y="1136576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48680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Ath_atp6-2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60" name="组合 59"/>
            <p:cNvGrpSpPr/>
            <p:nvPr/>
          </p:nvGrpSpPr>
          <p:grpSpPr>
            <a:xfrm>
              <a:off x="188640" y="2000672"/>
              <a:ext cx="1584176" cy="482763"/>
              <a:chOff x="188640" y="920552"/>
              <a:chExt cx="1584176" cy="482763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188640" y="1136576"/>
                <a:ext cx="1224136" cy="2667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C5-CMS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76672" y="920552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na_orf188a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48680" y="1034371"/>
                <a:ext cx="1224136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000" dirty="0" smtClean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Ath_atp6-2</a:t>
                </a:r>
                <a:endParaRPr lang="zh-CN" altLang="en-US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</p:grpSp>
      <p:pic>
        <p:nvPicPr>
          <p:cNvPr id="1032" name="Picture 8" descr="C:\Users\xiong\Desktop\进化图.em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1286" y="5170222"/>
            <a:ext cx="4467994" cy="21253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TextBox 66"/>
          <p:cNvSpPr txBox="1"/>
          <p:nvPr/>
        </p:nvSpPr>
        <p:spPr>
          <a:xfrm>
            <a:off x="116632" y="118583"/>
            <a:ext cx="442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2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06576" y="2056366"/>
            <a:ext cx="442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2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06576" y="3508498"/>
            <a:ext cx="442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</a:t>
            </a:r>
            <a:endParaRPr lang="zh-CN" altLang="en-US" sz="12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474728" y="5246874"/>
            <a:ext cx="442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</a:t>
            </a:r>
            <a:endParaRPr lang="zh-CN" altLang="en-US" sz="12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403016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4</Words>
  <Application>Microsoft Office PowerPoint</Application>
  <PresentationFormat>全屏显示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2</cp:revision>
  <dcterms:created xsi:type="dcterms:W3CDTF">2022-08-04T08:19:47Z</dcterms:created>
  <dcterms:modified xsi:type="dcterms:W3CDTF">2022-08-05T02:44:14Z</dcterms:modified>
</cp:coreProperties>
</file>